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104" d="100"/>
          <a:sy n="104" d="100"/>
        </p:scale>
        <p:origin x="23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8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/>
              <a:t>Footshock Reactivity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8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6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 cap="sq">
              <a:solidFill>
                <a:schemeClr val="tx1"/>
              </a:solidFill>
              <a:miter lim="800000"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002060"/>
              </a:solidFill>
              <a:ln w="3175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1-6ED9-6140-83F9-6F2D1B65DC3D}"/>
              </c:ext>
            </c:extLst>
          </c:dPt>
          <c:dPt>
            <c:idx val="3"/>
            <c:invertIfNegative val="0"/>
            <c:bubble3D val="0"/>
            <c:spPr>
              <a:solidFill>
                <a:srgbClr val="C00000"/>
              </a:solidFill>
              <a:ln w="3175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3-6ED9-6140-83F9-6F2D1B65DC3D}"/>
              </c:ext>
            </c:extLst>
          </c:dPt>
          <c:dPt>
            <c:idx val="5"/>
            <c:invertIfNegative val="0"/>
            <c:bubble3D val="0"/>
            <c:spPr>
              <a:solidFill>
                <a:srgbClr val="00B0F0"/>
              </a:solidFill>
              <a:ln w="3175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5-6ED9-6140-83F9-6F2D1B65DC3D}"/>
              </c:ext>
            </c:extLst>
          </c:dPt>
          <c:dPt>
            <c:idx val="7"/>
            <c:invertIfNegative val="0"/>
            <c:bubble3D val="0"/>
            <c:spPr>
              <a:solidFill>
                <a:srgbClr val="FF8AD8"/>
              </a:solidFill>
              <a:ln w="3175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7-6ED9-6140-83F9-6F2D1B65DC3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17:$J$17</c:f>
                <c:numCache>
                  <c:formatCode>General</c:formatCode>
                  <c:ptCount val="9"/>
                  <c:pt idx="0">
                    <c:v>218.15894454884659</c:v>
                  </c:pt>
                  <c:pt idx="1">
                    <c:v>320.66055458485204</c:v>
                  </c:pt>
                  <c:pt idx="2">
                    <c:v>149.7800400103134</c:v>
                  </c:pt>
                  <c:pt idx="3">
                    <c:v>156.97864183018089</c:v>
                  </c:pt>
                  <c:pt idx="4">
                    <c:v>153.3198786085988</c:v>
                  </c:pt>
                  <c:pt idx="5">
                    <c:v>286.26566656186736</c:v>
                  </c:pt>
                  <c:pt idx="6">
                    <c:v>314.04442245241245</c:v>
                  </c:pt>
                  <c:pt idx="7">
                    <c:v>219.04778917591597</c:v>
                  </c:pt>
                </c:numCache>
              </c:numRef>
            </c:plus>
            <c:minus>
              <c:numRef>
                <c:f>Sheet1!$B$17:$J$17</c:f>
                <c:numCache>
                  <c:formatCode>General</c:formatCode>
                  <c:ptCount val="9"/>
                  <c:pt idx="0">
                    <c:v>218.15894454884659</c:v>
                  </c:pt>
                  <c:pt idx="1">
                    <c:v>320.66055458485204</c:v>
                  </c:pt>
                  <c:pt idx="2">
                    <c:v>149.7800400103134</c:v>
                  </c:pt>
                  <c:pt idx="3">
                    <c:v>156.97864183018089</c:v>
                  </c:pt>
                  <c:pt idx="4">
                    <c:v>153.3198786085988</c:v>
                  </c:pt>
                  <c:pt idx="5">
                    <c:v>286.26566656186736</c:v>
                  </c:pt>
                  <c:pt idx="6">
                    <c:v>314.04442245241245</c:v>
                  </c:pt>
                  <c:pt idx="7">
                    <c:v>219.04778917591597</c:v>
                  </c:pt>
                </c:numCache>
              </c:numRef>
            </c:minus>
            <c:spPr>
              <a:noFill/>
              <a:ln w="6350" cap="sq" cmpd="sng" algn="ctr">
                <a:solidFill>
                  <a:schemeClr val="tx1"/>
                </a:solidFill>
                <a:miter lim="800000"/>
              </a:ln>
              <a:effectLst/>
            </c:spPr>
          </c:errBars>
          <c:cat>
            <c:multiLvlStrRef>
              <c:f>Sheet1!$B$14:$I$15</c:f>
              <c:multiLvlStrCache>
                <c:ptCount val="8"/>
                <c:lvl>
                  <c:pt idx="0">
                    <c:v>Pre-shock</c:v>
                  </c:pt>
                  <c:pt idx="1">
                    <c:v>Shock</c:v>
                  </c:pt>
                  <c:pt idx="2">
                    <c:v>Pre-shock</c:v>
                  </c:pt>
                  <c:pt idx="3">
                    <c:v>Shock</c:v>
                  </c:pt>
                  <c:pt idx="4">
                    <c:v>Pre-shock</c:v>
                  </c:pt>
                  <c:pt idx="5">
                    <c:v>Shock</c:v>
                  </c:pt>
                  <c:pt idx="6">
                    <c:v>Pre-shock</c:v>
                  </c:pt>
                  <c:pt idx="7">
                    <c:v>Shock</c:v>
                  </c:pt>
                </c:lvl>
                <c:lvl>
                  <c:pt idx="0">
                    <c:v>Male Sham</c:v>
                  </c:pt>
                  <c:pt idx="2">
                    <c:v>Female Sham</c:v>
                  </c:pt>
                  <c:pt idx="4">
                    <c:v>Male oRX</c:v>
                  </c:pt>
                  <c:pt idx="6">
                    <c:v>Female oVX</c:v>
                  </c:pt>
                </c:lvl>
              </c:multiLvlStrCache>
            </c:multiLvlStrRef>
          </c:cat>
          <c:val>
            <c:numRef>
              <c:f>Sheet1!$B$16:$I$16</c:f>
              <c:numCache>
                <c:formatCode>General</c:formatCode>
                <c:ptCount val="8"/>
                <c:pt idx="0">
                  <c:v>1288.1199999999999</c:v>
                </c:pt>
                <c:pt idx="1">
                  <c:v>6534.06</c:v>
                </c:pt>
                <c:pt idx="2">
                  <c:v>823.21624999999995</c:v>
                </c:pt>
                <c:pt idx="3">
                  <c:v>5605.6887499999993</c:v>
                </c:pt>
                <c:pt idx="4">
                  <c:v>1310.5090000000002</c:v>
                </c:pt>
                <c:pt idx="5">
                  <c:v>6099.9690000000001</c:v>
                </c:pt>
                <c:pt idx="6">
                  <c:v>1335.9985714285717</c:v>
                </c:pt>
                <c:pt idx="7">
                  <c:v>5171.1600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ED9-6140-83F9-6F2D1B65DC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8809776"/>
        <c:axId val="1628799056"/>
      </c:barChart>
      <c:catAx>
        <c:axId val="1628809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sq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28799056"/>
        <c:crosses val="autoZero"/>
        <c:auto val="1"/>
        <c:lblAlgn val="ctr"/>
        <c:lblOffset val="100"/>
        <c:noMultiLvlLbl val="0"/>
      </c:catAx>
      <c:valAx>
        <c:axId val="16287990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Motion Index (pixel changes)</a:t>
                </a:r>
              </a:p>
            </c:rich>
          </c:tx>
          <c:layout>
            <c:manualLayout>
              <c:xMode val="edge"/>
              <c:yMode val="edge"/>
              <c:x val="7.3244550172920581E-3"/>
              <c:y val="0.298374509406277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28809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28F843-1537-674A-0619-2E8E3586F0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AB9E64-2E38-440A-5F41-FA1075A07A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2F54B-4218-F785-CF63-9A9BB925A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94C34C-E139-51D7-C8D8-EEDEF67A7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7AB0DF-1046-8962-6062-F34AC2E972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24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B4C12-A1D8-6E48-3B2D-05BB4FB42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AF91DD8-8100-CB94-24C4-D72C44B44E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1599D7-FAE0-F120-7FFD-46E3838DCC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9FA5A0-C27A-FFAE-5D35-18F6315F3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E8CC46-CE61-D27A-8436-31B0F8E6E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231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B03409-E0AC-5F56-FD84-88858937BB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705173-5782-F8F3-D87B-B094A52F98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38ABF-8FDE-1A16-BDB5-63D43AD62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0E18F-B149-C69E-BF44-F2D466540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227E35-80A1-2E1D-DC0C-671F14957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53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3436B-BC64-D645-6BF7-CED68E3455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DE56C-28BE-F8C8-DA59-76B05F445C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570A01-BD6C-B11A-48C9-1F9C38D2A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C7F66-85CD-CFDA-EF97-5834E4C3A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56AFFB-0286-6B40-C22E-D8C7BA1A6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060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0BADD-AA16-F7C1-1B1D-411E65CA14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9E21A6-4771-B7A6-95A7-F17904BA6D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DA10A2-52BD-00D9-33B2-C38B4BFFB3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CF1152-97F9-6770-EFF3-A4D75235F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3BB508-8ED5-63D8-D785-CF964414F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395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BA1D16-E0CC-09B5-B13E-90016A033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28A2ED-FD05-2420-F6EA-A713AE6C55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6417C0-99F0-9182-99A3-9E1532B0A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FB111E-F4CC-4F1E-BFED-A30EFF918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53E8AB-A2AC-9157-691D-84CD622464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CFD281-6AB4-6363-5FFB-212E5EB0A2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028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34BDBB-0309-84F0-CDB2-5F088C4B64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4AA5FB-843C-6E79-29BF-E47A7EF6E4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C97D3F-8653-5642-A13C-40B2575D32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659A7C-07C6-DC17-A106-08FB75653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84D0EA-314C-7CA6-9E4A-2B4F3C1731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7616AA-2382-A15D-4D02-4CA7A34D3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8BE20F-E604-6BCD-E054-4B7B954C3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0DD383-9903-AC4F-29F0-ECD5A792E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24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557128-21EE-72E0-69D7-17551BF1F1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F8E045-1E2F-AB2D-A01A-03B681CCC5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2B2BC6-ADBA-2AD8-1362-677E1449F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1DD91F-294C-9634-64A9-F52CFF081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974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643D8B-DA20-361D-F739-B6F168506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383F8C-BEC9-3790-67FC-CF204A189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0F086BB-DFDC-9B5B-DD7F-87E01535E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880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BB437-B6D7-A9DD-1640-77C2248BD6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C24552-BC9C-7DE2-3C6D-48ECFA386A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6C8740-0EA5-C76F-8DA6-167AA989FA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88A12-F8C0-03BF-94F9-08E4EC12C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8A2656-580A-9D89-D5FD-827319327D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81039C-24C9-D45F-42E3-C94101A75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704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19894-A146-A2B6-5525-CBCEF5445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F44918-5F59-768C-6888-24FA8F61F7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03F56E-F999-06F3-BD53-7C83EB355A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D4E77C-AA9D-18E7-1A9B-5B73C44EC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41AD67-E8E4-D22E-011C-39BE7EFC3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075A3D-E1DF-6709-B86F-800B00B1C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7572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9BA0E0-54F9-52B1-1B89-EFED5F55D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A11828-C701-A414-4881-F6DC9149E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647CB1-A36B-FF48-5BAB-DC629CF02A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2D267-F2E4-6F48-875D-4E452F56017D}" type="datetimeFigureOut">
              <a:rPr lang="en-US" smtClean="0"/>
              <a:t>1/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4E3AFF-B73D-9C62-FFF0-DDDDE055F4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66FA0C-4AC0-0AB8-ED3A-BDDA37E884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AE71C-EBE4-9F4D-BFBF-7760C77F1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579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F584EB92-019C-AF07-0E46-D9B4FE26B7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289081"/>
              </p:ext>
            </p:extLst>
          </p:nvPr>
        </p:nvGraphicFramePr>
        <p:xfrm>
          <a:off x="1761206" y="285487"/>
          <a:ext cx="8669587" cy="62870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23FBE3E-F811-B3FF-E663-ADFC921363F7}"/>
              </a:ext>
            </a:extLst>
          </p:cNvPr>
          <p:cNvCxnSpPr>
            <a:cxnSpLocks/>
          </p:cNvCxnSpPr>
          <p:nvPr/>
        </p:nvCxnSpPr>
        <p:spPr>
          <a:xfrm>
            <a:off x="2990335" y="1054443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C2A8F4E-E522-4FC1-CF5F-9EEBD755DE75}"/>
              </a:ext>
            </a:extLst>
          </p:cNvPr>
          <p:cNvCxnSpPr>
            <a:cxnSpLocks/>
          </p:cNvCxnSpPr>
          <p:nvPr/>
        </p:nvCxnSpPr>
        <p:spPr>
          <a:xfrm>
            <a:off x="4909751" y="1054443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8ED1D01-0CFF-D8AA-A6EB-60BB6401CDB0}"/>
              </a:ext>
            </a:extLst>
          </p:cNvPr>
          <p:cNvCxnSpPr>
            <a:cxnSpLocks/>
          </p:cNvCxnSpPr>
          <p:nvPr/>
        </p:nvCxnSpPr>
        <p:spPr>
          <a:xfrm>
            <a:off x="3503140" y="885567"/>
            <a:ext cx="1919416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487F8C7-AF41-772F-88B9-8D86B7224E3D}"/>
              </a:ext>
            </a:extLst>
          </p:cNvPr>
          <p:cNvCxnSpPr/>
          <p:nvPr/>
        </p:nvCxnSpPr>
        <p:spPr>
          <a:xfrm>
            <a:off x="3503140" y="885567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1064B74-B9A5-E243-FAE2-CEA42F03094A}"/>
              </a:ext>
            </a:extLst>
          </p:cNvPr>
          <p:cNvCxnSpPr/>
          <p:nvPr/>
        </p:nvCxnSpPr>
        <p:spPr>
          <a:xfrm>
            <a:off x="5422559" y="889684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041A63A7-421D-6D2A-4AD1-94CF0B4AFB95}"/>
              </a:ext>
            </a:extLst>
          </p:cNvPr>
          <p:cNvSpPr txBox="1"/>
          <p:nvPr/>
        </p:nvSpPr>
        <p:spPr>
          <a:xfrm>
            <a:off x="4245481" y="618979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E8CBE3E3-193B-29ED-6E30-C20A456F72E2}"/>
              </a:ext>
            </a:extLst>
          </p:cNvPr>
          <p:cNvCxnSpPr>
            <a:cxnSpLocks/>
          </p:cNvCxnSpPr>
          <p:nvPr/>
        </p:nvCxnSpPr>
        <p:spPr>
          <a:xfrm>
            <a:off x="2965994" y="1452700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65F580AB-CB97-E04E-1405-21F999A7DA3F}"/>
              </a:ext>
            </a:extLst>
          </p:cNvPr>
          <p:cNvCxnSpPr>
            <a:cxnSpLocks/>
          </p:cNvCxnSpPr>
          <p:nvPr/>
        </p:nvCxnSpPr>
        <p:spPr>
          <a:xfrm>
            <a:off x="6901248" y="1459658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F8DBE0D-046C-5B84-80F9-69DE124CEF27}"/>
              </a:ext>
            </a:extLst>
          </p:cNvPr>
          <p:cNvCxnSpPr>
            <a:cxnSpLocks/>
          </p:cNvCxnSpPr>
          <p:nvPr/>
        </p:nvCxnSpPr>
        <p:spPr>
          <a:xfrm>
            <a:off x="3478799" y="1283824"/>
            <a:ext cx="3935255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378247A-B590-DB55-E86B-E1B89A6FB87D}"/>
              </a:ext>
            </a:extLst>
          </p:cNvPr>
          <p:cNvCxnSpPr/>
          <p:nvPr/>
        </p:nvCxnSpPr>
        <p:spPr>
          <a:xfrm>
            <a:off x="3478799" y="1283824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CB74A54-1E13-DE2E-2BF6-5FB22BD1FBF0}"/>
              </a:ext>
            </a:extLst>
          </p:cNvPr>
          <p:cNvCxnSpPr/>
          <p:nvPr/>
        </p:nvCxnSpPr>
        <p:spPr>
          <a:xfrm>
            <a:off x="7414054" y="1290782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AF5DE8A9-D98B-2F8F-0EBD-9D4A82DC294C}"/>
              </a:ext>
            </a:extLst>
          </p:cNvPr>
          <p:cNvSpPr txBox="1"/>
          <p:nvPr/>
        </p:nvSpPr>
        <p:spPr>
          <a:xfrm>
            <a:off x="6144105" y="1036021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FDBAE0B-9A2B-1CA1-AA57-B8AACBFE9773}"/>
              </a:ext>
            </a:extLst>
          </p:cNvPr>
          <p:cNvCxnSpPr>
            <a:cxnSpLocks/>
          </p:cNvCxnSpPr>
          <p:nvPr/>
        </p:nvCxnSpPr>
        <p:spPr>
          <a:xfrm>
            <a:off x="5008981" y="1876951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0235BCD2-82A7-6E2E-66A5-8826E0AF86DA}"/>
              </a:ext>
            </a:extLst>
          </p:cNvPr>
          <p:cNvCxnSpPr>
            <a:cxnSpLocks/>
          </p:cNvCxnSpPr>
          <p:nvPr/>
        </p:nvCxnSpPr>
        <p:spPr>
          <a:xfrm>
            <a:off x="8944235" y="1883909"/>
            <a:ext cx="102561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9062F66C-BF3C-1C37-2099-38D4EAC5C256}"/>
              </a:ext>
            </a:extLst>
          </p:cNvPr>
          <p:cNvCxnSpPr>
            <a:cxnSpLocks/>
          </p:cNvCxnSpPr>
          <p:nvPr/>
        </p:nvCxnSpPr>
        <p:spPr>
          <a:xfrm>
            <a:off x="5521786" y="1708075"/>
            <a:ext cx="3935255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897BD6A-8BBF-D665-52F9-C2B1D854DAEF}"/>
              </a:ext>
            </a:extLst>
          </p:cNvPr>
          <p:cNvCxnSpPr/>
          <p:nvPr/>
        </p:nvCxnSpPr>
        <p:spPr>
          <a:xfrm>
            <a:off x="5521786" y="1708075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D233F33F-1D0E-5EB0-2712-0BA64651CFB6}"/>
              </a:ext>
            </a:extLst>
          </p:cNvPr>
          <p:cNvCxnSpPr/>
          <p:nvPr/>
        </p:nvCxnSpPr>
        <p:spPr>
          <a:xfrm>
            <a:off x="9457041" y="1715033"/>
            <a:ext cx="0" cy="1688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79BAFCFE-EFEE-DEC9-24E1-6BDFF25CF052}"/>
              </a:ext>
            </a:extLst>
          </p:cNvPr>
          <p:cNvSpPr txBox="1"/>
          <p:nvPr/>
        </p:nvSpPr>
        <p:spPr>
          <a:xfrm>
            <a:off x="8284357" y="1470223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532522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11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ulos, Andrew</dc:creator>
  <cp:lastModifiedBy>Poulos, Andrew</cp:lastModifiedBy>
  <cp:revision>5</cp:revision>
  <dcterms:created xsi:type="dcterms:W3CDTF">2023-01-02T16:46:50Z</dcterms:created>
  <dcterms:modified xsi:type="dcterms:W3CDTF">2023-01-04T20:31:05Z</dcterms:modified>
</cp:coreProperties>
</file>